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6"/>
  </p:notesMasterIdLst>
  <p:sldIdLst>
    <p:sldId id="261" r:id="rId2"/>
    <p:sldId id="264" r:id="rId3"/>
    <p:sldId id="265" r:id="rId4"/>
    <p:sldId id="29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4624" autoAdjust="0"/>
  </p:normalViewPr>
  <p:slideViewPr>
    <p:cSldViewPr snapToGrid="0">
      <p:cViewPr varScale="1">
        <p:scale>
          <a:sx n="56" d="100"/>
          <a:sy n="56" d="100"/>
        </p:scale>
        <p:origin x="996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6DB05A-45A0-4B2A-93B1-ECF4534E4D56}" type="datetimeFigureOut">
              <a:rPr lang="en-GB" smtClean="0"/>
              <a:pPr/>
              <a:t>10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1BEF60-1C26-49B3-89AF-2C725BCB304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1783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1BEF60-1C26-49B3-89AF-2C725BCB3049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1202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1BEF60-1C26-49B3-89AF-2C725BCB3049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327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3D2645-005F-4E09-8DCD-9048726FAC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2D9714-56A8-4A80-A5BA-A95A23A296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6C2621-406C-4C94-A202-A77C89879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D34F-5248-407B-9895-848D88CF455E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D933E5-AA5F-4F91-AE9B-DA089778F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1FDB11-3D58-41B3-94C5-777C283A8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4848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12CC8-1D00-436D-BB45-3461514CC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CBBEC3-7CFD-47C3-A5B7-E8810A20CB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865894-D0DD-4EEB-B8CA-C9C2672FF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ED9E1-151F-499E-A8C3-F09712C492AE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F3639-F3C4-43FB-A4E2-F1554E0863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6F40A7-AF87-4FE5-BF0D-DFAC9874C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841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0EA0B2-6FDA-4D3E-B90A-1358294602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8FC031-DE21-4823-836A-DC6B4DFF1C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1BDF1E-13B9-42B4-9220-605B5B3F0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B4F1F-9D36-4FA7-BBA8-D35171FE3F55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30C83C-13A7-471F-BDC3-77199BDDA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27A318-DC58-4B72-88C6-8BB09A873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67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02C3B4-A7BE-43DC-A8BE-517886CBE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80AC7C-EC96-4D79-B406-4EAEE3603E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1285F4-A85C-4FAE-8CA2-1D3C8A8AE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CDA3E-3152-4952-BF33-EAAF28075C2A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834F3D-112F-4C1F-88B4-05833B689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0DA1D-22A2-4453-9F19-118D43204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4266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7A84D8-4376-4D95-928F-6FE5AD891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269966-FDEB-4DF3-804D-A70E66CB2D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C83FF4-BFC4-4654-B432-A070C98D9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8929-06AE-4C55-BC3A-204F7639A280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DF3EA5-E268-4FF5-899A-32FFE40DD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1E6899-562D-4598-B4B3-71FFB83C6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873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AB0F4-93F2-42E1-A2F9-9E4920CDEF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90CF14-046D-4B88-B6D0-877F59742C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2BF99E-F406-47AC-B95D-F74F60E103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0B46E0-375A-4A98-8FAE-913BABF43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CE450-351F-46A6-830B-81ED9F31AA68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C0C795-47C4-4BD9-B708-27000BCB4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527774-1C54-448D-8C82-90CFC6A9A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362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869912-81B0-4467-8D7B-28A943B06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661C5C-4FA1-465C-9618-372DD88097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CEFB34-D3D9-45A0-9D45-180AB49B4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6C6F54-FA2F-4EFA-9A6E-EF5EA5D0AD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D7C5D3-75C4-4387-87B5-7AAE4463A7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F2E155-9C40-498D-99B3-4536665DE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F8585-98A6-48DF-A3A2-7654BF914A00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311B42-C562-490C-A424-BA475B0EB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08B9FC-0F0C-4378-938E-822EB351E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2873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F4AD7-EE7C-4B7B-BFA8-5872E079EB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7600DE-9917-43EA-B4EE-77FA21D79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36EC1-8C84-4664-B127-9BAC05397D47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B62282-0679-4B3F-8F0A-40BB9BCAA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29226D-1FC3-400F-AA11-7B7111932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1723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15D70C-F340-47D3-81B5-60C14C269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F010D-A52A-450B-86D6-F4A3D1D88BC4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C760CA-949D-4FEA-923C-49F93AF38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C76B72-6E8D-41E7-ADE7-ADED76655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3364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E9FC5-DF31-42A4-A4F7-CD8250CB4F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4770B8-16AE-491F-B6EB-F050F2E3E0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F831C6-D829-4731-9A52-7BA06F625B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2A8B4E-22B0-4297-9F13-ACB12CF54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E8867-D9CC-4308-8FB3-2FD0DEBCF247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3F3577-F3F4-4C86-AEA8-2ABDB3622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BAD5E4-B2AC-46AE-9B6E-B84857442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23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DC985-3BE6-40EF-9E3C-BBF33A6556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97BC00A-A944-4315-A407-E20791D3EF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D6FD1B-7B3B-4217-B27F-043A1D915E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6E3367-E2AE-4219-9AD2-60C37146D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4DE7F-E268-4A28-A408-B476957B7376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7A903B-C97C-4746-835A-64340A5F0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F484A4-B1E6-4A3F-A112-375FD8A3E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6864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8101C5-1DC8-461A-A035-6B5637C32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709727-1B81-42B6-ABEA-C4E8451D84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405B0D-308A-4705-8295-CB9E1DF439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028929-06AE-4C55-BC3A-204F7639A280}" type="datetime1">
              <a:rPr lang="en-GB" smtClean="0"/>
              <a:pPr/>
              <a:t>10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C3FB0-C49C-4587-B8A0-018B696064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C97F1-3F35-41D9-A54E-95BDEC360D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10A5B-3A5D-4F1B-9268-76F47EAFFF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5793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91D4198-030D-47FA-BF41-FC221D578D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6846351"/>
              </p:ext>
            </p:extLst>
          </p:nvPr>
        </p:nvGraphicFramePr>
        <p:xfrm>
          <a:off x="3909061" y="914401"/>
          <a:ext cx="4361021" cy="563879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72881">
                  <a:extLst>
                    <a:ext uri="{9D8B030D-6E8A-4147-A177-3AD203B41FA5}">
                      <a16:colId xmlns:a16="http://schemas.microsoft.com/office/drawing/2014/main" val="186579926"/>
                    </a:ext>
                  </a:extLst>
                </a:gridCol>
                <a:gridCol w="1358147">
                  <a:extLst>
                    <a:ext uri="{9D8B030D-6E8A-4147-A177-3AD203B41FA5}">
                      <a16:colId xmlns:a16="http://schemas.microsoft.com/office/drawing/2014/main" val="604863788"/>
                    </a:ext>
                  </a:extLst>
                </a:gridCol>
                <a:gridCol w="1257153">
                  <a:extLst>
                    <a:ext uri="{9D8B030D-6E8A-4147-A177-3AD203B41FA5}">
                      <a16:colId xmlns:a16="http://schemas.microsoft.com/office/drawing/2014/main" val="440339985"/>
                    </a:ext>
                  </a:extLst>
                </a:gridCol>
                <a:gridCol w="772840">
                  <a:extLst>
                    <a:ext uri="{9D8B030D-6E8A-4147-A177-3AD203B41FA5}">
                      <a16:colId xmlns:a16="http://schemas.microsoft.com/office/drawing/2014/main" val="256901752"/>
                    </a:ext>
                  </a:extLst>
                </a:gridCol>
              </a:tblGrid>
              <a:tr h="985313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 Sample Name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 Total Read Count </a:t>
                      </a:r>
                    </a:p>
                    <a:p>
                      <a:pPr algn="ctr" rtl="0" fontAlgn="b"/>
                      <a:r>
                        <a:rPr lang="en-GB" sz="1600" b="1" dirty="0"/>
                        <a:t>PE-2 × 100 bp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ter adapter trimming and quality filtration</a:t>
                      </a: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read length</a:t>
                      </a: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9989842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C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4,922,135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,922,135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3542754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C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0,476,54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,476,542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8056529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C_3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7,505,41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,505,412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3541099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12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3,552,645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,552,645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8080803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12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6,556,77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556,772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9031169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24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3,398,350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,398,350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1034870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24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7,335,826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dirty="0"/>
                        <a:t>34,922,135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2079633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24_3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6,159,584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,159,584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4086449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36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0,399,434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,399,434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6229343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36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29,599,827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599,827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6147211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48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25,839,28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dirty="0"/>
                        <a:t>23,367,667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3575243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48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7,637,906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,637,906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8232679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60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6,568,59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,568,591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7444847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60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8,134,238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,134,238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9442840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60_3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0,109,830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,109,830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1426602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72_1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5,451,239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,451,239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7595767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72_2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31,036,499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,036,499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6883734"/>
                  </a:ext>
                </a:extLst>
              </a:tr>
              <a:tr h="258527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600" u="none" strike="noStrike" dirty="0">
                          <a:effectLst/>
                        </a:rPr>
                        <a:t> 72_3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u="none" strike="noStrike" dirty="0">
                          <a:effectLst/>
                        </a:rPr>
                        <a:t>44,030,873 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67" marR="5467" marT="546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,030,873 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075962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5224B57-4215-4840-84C9-88808F332272}"/>
              </a:ext>
            </a:extLst>
          </p:cNvPr>
          <p:cNvSpPr txBox="1"/>
          <p:nvPr/>
        </p:nvSpPr>
        <p:spPr>
          <a:xfrm>
            <a:off x="4789937" y="240853"/>
            <a:ext cx="26121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/>
              <a:t>RNA-</a:t>
            </a:r>
            <a:r>
              <a:rPr lang="en-GB" sz="2000" b="1" dirty="0" err="1"/>
              <a:t>seq</a:t>
            </a:r>
            <a:r>
              <a:rPr lang="en-GB" sz="2000" b="1" dirty="0"/>
              <a:t> data statistic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752D40D-2579-4AAC-AC49-DE6F0CBAEE1D}"/>
              </a:ext>
            </a:extLst>
          </p:cNvPr>
          <p:cNvSpPr/>
          <p:nvPr/>
        </p:nvSpPr>
        <p:spPr>
          <a:xfrm>
            <a:off x="8755690" y="6330668"/>
            <a:ext cx="1621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paired end (PE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244DAD-D935-4D08-A0B8-92C33C414101}"/>
              </a:ext>
            </a:extLst>
          </p:cNvPr>
          <p:cNvSpPr txBox="1"/>
          <p:nvPr/>
        </p:nvSpPr>
        <p:spPr>
          <a:xfrm>
            <a:off x="739739" y="1551398"/>
            <a:ext cx="22911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AdapterRemoval</a:t>
            </a:r>
            <a:r>
              <a:rPr lang="en-GB" dirty="0"/>
              <a:t> v2</a:t>
            </a:r>
          </a:p>
          <a:p>
            <a:r>
              <a:rPr lang="en-GB" dirty="0"/>
              <a:t>--</a:t>
            </a:r>
            <a:r>
              <a:rPr lang="en-GB" dirty="0" err="1"/>
              <a:t>minquality</a:t>
            </a:r>
            <a:r>
              <a:rPr lang="en-GB" dirty="0"/>
              <a:t> 25</a:t>
            </a:r>
          </a:p>
          <a:p>
            <a:r>
              <a:rPr lang="en-GB" dirty="0"/>
              <a:t>--Adapter.txt</a:t>
            </a:r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43800234-79A7-4B66-8B78-DA9C6A3CB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1</a:t>
            </a:fld>
            <a:endParaRPr lang="en-GB"/>
          </a:p>
        </p:txBody>
      </p:sp>
      <p:sp>
        <p:nvSpPr>
          <p:cNvPr id="9" name="TextBox 8"/>
          <p:cNvSpPr txBox="1"/>
          <p:nvPr/>
        </p:nvSpPr>
        <p:spPr>
          <a:xfrm>
            <a:off x="736978" y="259308"/>
            <a:ext cx="1583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able 1:</a:t>
            </a:r>
          </a:p>
        </p:txBody>
      </p:sp>
    </p:spTree>
    <p:extLst>
      <p:ext uri="{BB962C8B-B14F-4D97-AF65-F5344CB8AC3E}">
        <p14:creationId xmlns:p14="http://schemas.microsoft.com/office/powerpoint/2010/main" val="2652485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F9897EB-DE19-4E4C-B32C-60592611B4FC}"/>
              </a:ext>
            </a:extLst>
          </p:cNvPr>
          <p:cNvSpPr/>
          <p:nvPr/>
        </p:nvSpPr>
        <p:spPr>
          <a:xfrm>
            <a:off x="4449763" y="373147"/>
            <a:ext cx="329247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000000"/>
                </a:solidFill>
                <a:latin typeface="Calibri" panose="020F0502020204030204" pitchFamily="34" charset="0"/>
              </a:rPr>
              <a:t>STAR 1st pass mapping statistics</a:t>
            </a:r>
            <a:r>
              <a:rPr lang="en-GB" dirty="0"/>
              <a:t>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EA803A4-E599-4E9D-B06C-787C856AD9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4057735"/>
              </p:ext>
            </p:extLst>
          </p:nvPr>
        </p:nvGraphicFramePr>
        <p:xfrm>
          <a:off x="4583430" y="1268729"/>
          <a:ext cx="7437334" cy="44545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84268">
                  <a:extLst>
                    <a:ext uri="{9D8B030D-6E8A-4147-A177-3AD203B41FA5}">
                      <a16:colId xmlns:a16="http://schemas.microsoft.com/office/drawing/2014/main" val="369538423"/>
                    </a:ext>
                  </a:extLst>
                </a:gridCol>
                <a:gridCol w="888574">
                  <a:extLst>
                    <a:ext uri="{9D8B030D-6E8A-4147-A177-3AD203B41FA5}">
                      <a16:colId xmlns:a16="http://schemas.microsoft.com/office/drawing/2014/main" val="168868630"/>
                    </a:ext>
                  </a:extLst>
                </a:gridCol>
                <a:gridCol w="596440">
                  <a:extLst>
                    <a:ext uri="{9D8B030D-6E8A-4147-A177-3AD203B41FA5}">
                      <a16:colId xmlns:a16="http://schemas.microsoft.com/office/drawing/2014/main" val="2673446869"/>
                    </a:ext>
                  </a:extLst>
                </a:gridCol>
                <a:gridCol w="1010296">
                  <a:extLst>
                    <a:ext uri="{9D8B030D-6E8A-4147-A177-3AD203B41FA5}">
                      <a16:colId xmlns:a16="http://schemas.microsoft.com/office/drawing/2014/main" val="2841828956"/>
                    </a:ext>
                  </a:extLst>
                </a:gridCol>
                <a:gridCol w="596440">
                  <a:extLst>
                    <a:ext uri="{9D8B030D-6E8A-4147-A177-3AD203B41FA5}">
                      <a16:colId xmlns:a16="http://schemas.microsoft.com/office/drawing/2014/main" val="1668395120"/>
                    </a:ext>
                  </a:extLst>
                </a:gridCol>
                <a:gridCol w="937262">
                  <a:extLst>
                    <a:ext uri="{9D8B030D-6E8A-4147-A177-3AD203B41FA5}">
                      <a16:colId xmlns:a16="http://schemas.microsoft.com/office/drawing/2014/main" val="852179107"/>
                    </a:ext>
                  </a:extLst>
                </a:gridCol>
                <a:gridCol w="596440">
                  <a:extLst>
                    <a:ext uri="{9D8B030D-6E8A-4147-A177-3AD203B41FA5}">
                      <a16:colId xmlns:a16="http://schemas.microsoft.com/office/drawing/2014/main" val="1453412241"/>
                    </a:ext>
                  </a:extLst>
                </a:gridCol>
                <a:gridCol w="937262">
                  <a:extLst>
                    <a:ext uri="{9D8B030D-6E8A-4147-A177-3AD203B41FA5}">
                      <a16:colId xmlns:a16="http://schemas.microsoft.com/office/drawing/2014/main" val="3846991042"/>
                    </a:ext>
                  </a:extLst>
                </a:gridCol>
                <a:gridCol w="596440">
                  <a:extLst>
                    <a:ext uri="{9D8B030D-6E8A-4147-A177-3AD203B41FA5}">
                      <a16:colId xmlns:a16="http://schemas.microsoft.com/office/drawing/2014/main" val="169374419"/>
                    </a:ext>
                  </a:extLst>
                </a:gridCol>
                <a:gridCol w="693912">
                  <a:extLst>
                    <a:ext uri="{9D8B030D-6E8A-4147-A177-3AD203B41FA5}">
                      <a16:colId xmlns:a16="http://schemas.microsoft.com/office/drawing/2014/main" val="3002185422"/>
                    </a:ext>
                  </a:extLst>
                </a:gridCol>
              </a:tblGrid>
              <a:tr h="117549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input read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Average input read length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Uniquely mapped reads number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Uniquely mapped reads 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reads mapped to multiple loci (</a:t>
                      </a:r>
                      <a:r>
                        <a:rPr lang="en-GB" sz="1100" b="1" u="none" strike="noStrike" dirty="0" err="1">
                          <a:effectLst/>
                        </a:rPr>
                        <a:t>upto</a:t>
                      </a:r>
                      <a:r>
                        <a:rPr lang="en-GB" sz="1100" b="1" u="none" strike="noStrike" dirty="0">
                          <a:effectLst/>
                        </a:rPr>
                        <a:t> 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% of reads mapped to multiple loci (</a:t>
                      </a:r>
                      <a:r>
                        <a:rPr lang="en-GB" sz="1100" b="1" u="none" strike="noStrike" dirty="0" err="1">
                          <a:effectLst/>
                        </a:rPr>
                        <a:t>upto</a:t>
                      </a:r>
                      <a:r>
                        <a:rPr lang="en-GB" sz="1100" b="1" u="none" strike="noStrike" dirty="0">
                          <a:effectLst/>
                        </a:rPr>
                        <a:t> 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reads mapped to too many loci (&gt;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% of reads mapped to too many loci (&gt;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reads unmapped: other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3429953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C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4,922,13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19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2,493,20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03,15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25,30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2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47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6826219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C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0,476,54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19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7,238,57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583,36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54,35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4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383931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C_3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7,505,41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4,175,53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794,22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535,02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2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5549299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12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3,552,64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0,359,01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234,07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959,34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406310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12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6,556,77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3,257,93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416,83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881,60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40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8527596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24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3,398,35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0,965,77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052,11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380,25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2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7482554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24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4,922,13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2,493,20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03,15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25,30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47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6393582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24_3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6,159,58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3,948,64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4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51,90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358,01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0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1316254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36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0,399,43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8,667,90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4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557,27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173,95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30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0593224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36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29,599,82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7,641,94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597,41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360,24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2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9750322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48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23,367,66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2,144,13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5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102,70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120,69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3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9073724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48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7,637,90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5,124,42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34,14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79,08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4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9462785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60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6,568,59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3,822,45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4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321,02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424,27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83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0104594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60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8,134,23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5,689,67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4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029,83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413,43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29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1314900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60_3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0,109,83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5,351,48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88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217,79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538,39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15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1519416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72_1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5,451,23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2,990,72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14,88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43,66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552773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72_2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1,036,49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8,968,46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656,31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408,28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343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334566"/>
                  </a:ext>
                </a:extLst>
              </a:tr>
              <a:tr h="18194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u="none" strike="noStrike">
                          <a:effectLst/>
                        </a:rPr>
                        <a:t> 72_3 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       44,030,873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           41,212,071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4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264,01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5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553,62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115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5367576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D1BF873-29D7-40F3-92FC-FFD4E6D10EB4}"/>
              </a:ext>
            </a:extLst>
          </p:cNvPr>
          <p:cNvSpPr txBox="1"/>
          <p:nvPr/>
        </p:nvSpPr>
        <p:spPr>
          <a:xfrm>
            <a:off x="315194" y="5203861"/>
            <a:ext cx="370200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plice junctions </a:t>
            </a:r>
          </a:p>
          <a:p>
            <a:r>
              <a:rPr lang="en-GB" b="1" dirty="0"/>
              <a:t>Novel – 213,128</a:t>
            </a:r>
          </a:p>
          <a:p>
            <a:r>
              <a:rPr lang="en-GB" b="1" dirty="0"/>
              <a:t>Annotated </a:t>
            </a:r>
            <a:r>
              <a:rPr lang="en-GB" b="1" dirty="0" err="1"/>
              <a:t>ensembl</a:t>
            </a:r>
            <a:r>
              <a:rPr lang="en-GB" b="1" dirty="0"/>
              <a:t> – 101,766</a:t>
            </a:r>
          </a:p>
          <a:p>
            <a:r>
              <a:rPr lang="en-GB" b="1" dirty="0"/>
              <a:t>Total – 314,894‬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B405882-44DE-45F0-BE92-89C46E4B63F9}"/>
              </a:ext>
            </a:extLst>
          </p:cNvPr>
          <p:cNvSpPr txBox="1"/>
          <p:nvPr/>
        </p:nvSpPr>
        <p:spPr>
          <a:xfrm>
            <a:off x="123290" y="1654139"/>
            <a:ext cx="4736386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-</a:t>
            </a:r>
            <a:r>
              <a:rPr lang="en-GB" dirty="0" err="1"/>
              <a:t>sjdbOverhang</a:t>
            </a:r>
            <a:r>
              <a:rPr lang="en-GB" dirty="0"/>
              <a:t> 100</a:t>
            </a:r>
          </a:p>
          <a:p>
            <a:r>
              <a:rPr lang="en-GB" dirty="0"/>
              <a:t>--</a:t>
            </a:r>
            <a:r>
              <a:rPr lang="en-GB" dirty="0" err="1"/>
              <a:t>outSAMprimaryFlag</a:t>
            </a:r>
            <a:r>
              <a:rPr lang="en-GB" dirty="0"/>
              <a:t> </a:t>
            </a:r>
            <a:r>
              <a:rPr lang="en-GB" dirty="0" err="1"/>
              <a:t>AllBestScore</a:t>
            </a:r>
            <a:endParaRPr lang="en-GB" dirty="0"/>
          </a:p>
          <a:p>
            <a:r>
              <a:rPr lang="en-GB" dirty="0"/>
              <a:t>--</a:t>
            </a:r>
            <a:r>
              <a:rPr lang="en-GB" dirty="0" err="1"/>
              <a:t>outFilterMismatchNmax</a:t>
            </a:r>
            <a:r>
              <a:rPr lang="en-GB" dirty="0"/>
              <a:t> 2</a:t>
            </a:r>
          </a:p>
          <a:p>
            <a:r>
              <a:rPr lang="en-GB" dirty="0"/>
              <a:t>--</a:t>
            </a:r>
            <a:r>
              <a:rPr lang="en-GB" dirty="0" err="1"/>
              <a:t>outSJfilterCountTotalMin</a:t>
            </a:r>
            <a:r>
              <a:rPr lang="en-GB" dirty="0"/>
              <a:t> 10 5 5 5</a:t>
            </a:r>
          </a:p>
          <a:p>
            <a:r>
              <a:rPr lang="en-GB" dirty="0"/>
              <a:t>--</a:t>
            </a:r>
            <a:r>
              <a:rPr lang="en-GB" dirty="0" err="1"/>
              <a:t>outSAMstrandField</a:t>
            </a:r>
            <a:r>
              <a:rPr lang="en-GB" dirty="0"/>
              <a:t> </a:t>
            </a:r>
            <a:r>
              <a:rPr lang="en-GB" dirty="0" err="1"/>
              <a:t>intronMotif</a:t>
            </a:r>
            <a:endParaRPr lang="en-GB" dirty="0"/>
          </a:p>
          <a:p>
            <a:r>
              <a:rPr lang="en-GB" dirty="0"/>
              <a:t>--</a:t>
            </a:r>
            <a:r>
              <a:rPr lang="en-GB" dirty="0" err="1"/>
              <a:t>outFilterIntronMotifs</a:t>
            </a:r>
            <a:r>
              <a:rPr lang="en-GB" dirty="0"/>
              <a:t> </a:t>
            </a:r>
            <a:r>
              <a:rPr lang="en-GB" dirty="0" err="1"/>
              <a:t>RemoveNoncanonical</a:t>
            </a:r>
            <a:endParaRPr lang="en-GB" dirty="0"/>
          </a:p>
          <a:p>
            <a:r>
              <a:rPr lang="en-GB" dirty="0"/>
              <a:t>--</a:t>
            </a:r>
            <a:r>
              <a:rPr lang="en-GB" dirty="0" err="1"/>
              <a:t>alignIntronMin</a:t>
            </a:r>
            <a:r>
              <a:rPr lang="en-GB" dirty="0"/>
              <a:t> 60</a:t>
            </a:r>
          </a:p>
          <a:p>
            <a:r>
              <a:rPr lang="en-GB" dirty="0"/>
              <a:t>--</a:t>
            </a:r>
            <a:r>
              <a:rPr lang="en-GB" dirty="0" err="1"/>
              <a:t>alignIntronMax</a:t>
            </a:r>
            <a:r>
              <a:rPr lang="en-GB" dirty="0"/>
              <a:t> 6000</a:t>
            </a:r>
          </a:p>
          <a:p>
            <a:r>
              <a:rPr lang="en-GB" dirty="0"/>
              <a:t>--</a:t>
            </a:r>
            <a:r>
              <a:rPr lang="en-GB" dirty="0" err="1"/>
              <a:t>outFilterScoreMinOverLread</a:t>
            </a:r>
            <a:r>
              <a:rPr lang="en-GB" dirty="0"/>
              <a:t> 0</a:t>
            </a:r>
          </a:p>
          <a:p>
            <a:r>
              <a:rPr lang="en-GB" dirty="0"/>
              <a:t>--</a:t>
            </a:r>
            <a:r>
              <a:rPr lang="en-GB" dirty="0" err="1"/>
              <a:t>outFilterMatchNminOverLread</a:t>
            </a:r>
            <a:r>
              <a:rPr lang="en-GB" dirty="0"/>
              <a:t> 0</a:t>
            </a:r>
          </a:p>
          <a:p>
            <a:r>
              <a:rPr lang="en-GB" dirty="0"/>
              <a:t>--</a:t>
            </a:r>
            <a:r>
              <a:rPr lang="en-GB" dirty="0" err="1"/>
              <a:t>alignMatesGapMax</a:t>
            </a:r>
            <a:r>
              <a:rPr lang="en-GB" dirty="0"/>
              <a:t> 40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9E60DAE-C042-4D5E-9C36-EA7395368C93}"/>
              </a:ext>
            </a:extLst>
          </p:cNvPr>
          <p:cNvSpPr txBox="1"/>
          <p:nvPr/>
        </p:nvSpPr>
        <p:spPr>
          <a:xfrm>
            <a:off x="123290" y="2280867"/>
            <a:ext cx="2866490" cy="2769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2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87B0B7-243D-48E2-BF7C-9EFCDDDA3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2</a:t>
            </a:fld>
            <a:endParaRPr lang="en-GB"/>
          </a:p>
        </p:txBody>
      </p:sp>
      <p:sp>
        <p:nvSpPr>
          <p:cNvPr id="8" name="TextBox 7"/>
          <p:cNvSpPr txBox="1"/>
          <p:nvPr/>
        </p:nvSpPr>
        <p:spPr>
          <a:xfrm>
            <a:off x="736978" y="259308"/>
            <a:ext cx="1583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able 2:</a:t>
            </a:r>
          </a:p>
        </p:txBody>
      </p:sp>
    </p:spTree>
    <p:extLst>
      <p:ext uri="{BB962C8B-B14F-4D97-AF65-F5344CB8AC3E}">
        <p14:creationId xmlns:p14="http://schemas.microsoft.com/office/powerpoint/2010/main" val="792197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A7E7832-34C7-4EC3-8B8F-C8B1019035CF}"/>
              </a:ext>
            </a:extLst>
          </p:cNvPr>
          <p:cNvSpPr/>
          <p:nvPr/>
        </p:nvSpPr>
        <p:spPr>
          <a:xfrm>
            <a:off x="4411663" y="324675"/>
            <a:ext cx="336867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rgbClr val="000000"/>
                </a:solidFill>
                <a:latin typeface="Calibri" panose="020F0502020204030204" pitchFamily="34" charset="0"/>
              </a:rPr>
              <a:t>STAR 2nd pass mapping statistics</a:t>
            </a:r>
            <a:r>
              <a:rPr lang="en-GB" dirty="0"/>
              <a:t>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4B77D41-07D9-4833-B20F-263334B304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6329164"/>
              </p:ext>
            </p:extLst>
          </p:nvPr>
        </p:nvGraphicFramePr>
        <p:xfrm>
          <a:off x="4471512" y="1252533"/>
          <a:ext cx="7446510" cy="446589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89586">
                  <a:extLst>
                    <a:ext uri="{9D8B030D-6E8A-4147-A177-3AD203B41FA5}">
                      <a16:colId xmlns:a16="http://schemas.microsoft.com/office/drawing/2014/main" val="3553786973"/>
                    </a:ext>
                  </a:extLst>
                </a:gridCol>
                <a:gridCol w="896662">
                  <a:extLst>
                    <a:ext uri="{9D8B030D-6E8A-4147-A177-3AD203B41FA5}">
                      <a16:colId xmlns:a16="http://schemas.microsoft.com/office/drawing/2014/main" val="4256984724"/>
                    </a:ext>
                  </a:extLst>
                </a:gridCol>
                <a:gridCol w="601869">
                  <a:extLst>
                    <a:ext uri="{9D8B030D-6E8A-4147-A177-3AD203B41FA5}">
                      <a16:colId xmlns:a16="http://schemas.microsoft.com/office/drawing/2014/main" val="2508721656"/>
                    </a:ext>
                  </a:extLst>
                </a:gridCol>
                <a:gridCol w="1019493">
                  <a:extLst>
                    <a:ext uri="{9D8B030D-6E8A-4147-A177-3AD203B41FA5}">
                      <a16:colId xmlns:a16="http://schemas.microsoft.com/office/drawing/2014/main" val="2225166625"/>
                    </a:ext>
                  </a:extLst>
                </a:gridCol>
                <a:gridCol w="601869">
                  <a:extLst>
                    <a:ext uri="{9D8B030D-6E8A-4147-A177-3AD203B41FA5}">
                      <a16:colId xmlns:a16="http://schemas.microsoft.com/office/drawing/2014/main" val="314225200"/>
                    </a:ext>
                  </a:extLst>
                </a:gridCol>
                <a:gridCol w="945794">
                  <a:extLst>
                    <a:ext uri="{9D8B030D-6E8A-4147-A177-3AD203B41FA5}">
                      <a16:colId xmlns:a16="http://schemas.microsoft.com/office/drawing/2014/main" val="761094420"/>
                    </a:ext>
                  </a:extLst>
                </a:gridCol>
                <a:gridCol w="601869">
                  <a:extLst>
                    <a:ext uri="{9D8B030D-6E8A-4147-A177-3AD203B41FA5}">
                      <a16:colId xmlns:a16="http://schemas.microsoft.com/office/drawing/2014/main" val="3937108759"/>
                    </a:ext>
                  </a:extLst>
                </a:gridCol>
                <a:gridCol w="945794">
                  <a:extLst>
                    <a:ext uri="{9D8B030D-6E8A-4147-A177-3AD203B41FA5}">
                      <a16:colId xmlns:a16="http://schemas.microsoft.com/office/drawing/2014/main" val="1065322835"/>
                    </a:ext>
                  </a:extLst>
                </a:gridCol>
                <a:gridCol w="566740">
                  <a:extLst>
                    <a:ext uri="{9D8B030D-6E8A-4147-A177-3AD203B41FA5}">
                      <a16:colId xmlns:a16="http://schemas.microsoft.com/office/drawing/2014/main" val="2402149921"/>
                    </a:ext>
                  </a:extLst>
                </a:gridCol>
                <a:gridCol w="676834">
                  <a:extLst>
                    <a:ext uri="{9D8B030D-6E8A-4147-A177-3AD203B41FA5}">
                      <a16:colId xmlns:a16="http://schemas.microsoft.com/office/drawing/2014/main" val="3560597540"/>
                    </a:ext>
                  </a:extLst>
                </a:gridCol>
              </a:tblGrid>
              <a:tr h="106501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input read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Average input read length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Uniquely mapped reads number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Uniquely mapped reads 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reads mapped to multiple loci (</a:t>
                      </a:r>
                      <a:r>
                        <a:rPr lang="en-GB" sz="1100" b="1" u="none" strike="noStrike" dirty="0" err="1">
                          <a:effectLst/>
                        </a:rPr>
                        <a:t>upto</a:t>
                      </a:r>
                      <a:r>
                        <a:rPr lang="en-GB" sz="1100" b="1" u="none" strike="noStrike" dirty="0">
                          <a:effectLst/>
                        </a:rPr>
                        <a:t> 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% of reads mapped to multiple loci (</a:t>
                      </a:r>
                      <a:r>
                        <a:rPr lang="en-GB" sz="1100" b="1" u="none" strike="noStrike" dirty="0" err="1">
                          <a:effectLst/>
                        </a:rPr>
                        <a:t>upto</a:t>
                      </a:r>
                      <a:r>
                        <a:rPr lang="en-GB" sz="1100" b="1" u="none" strike="noStrike" dirty="0">
                          <a:effectLst/>
                        </a:rPr>
                        <a:t> 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reads mapped to too many loci (&gt;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% of reads mapped to too many loci (&gt;1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umber of reads unmapped: other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9616548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C_1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4,922,13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2,234,21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30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           2,052,046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5.88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              634,010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1.82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86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1319526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>
                          <a:effectLst/>
                        </a:rPr>
                        <a:t> C_2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0,476,54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6,898,54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1.16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884,21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7.13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74,04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67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3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7701708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C_3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7,505,41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3,739,18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07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,204,15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74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557,52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17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454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7049418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12_1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3,552,64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0,033,28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1.92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538,76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83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970,33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2.23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026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4528297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12_2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6,556,77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2,871,81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09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781,36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97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897,79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93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79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2121601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>
                          <a:effectLst/>
                        </a:rPr>
                        <a:t> 24_1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3,398,35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0,702,55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1.9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300,53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89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391,14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17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411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0814447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24_2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4,922,13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2,234,21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30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052,04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88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34,01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8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186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8702479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24_3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6,159,58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3,622,13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98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167,77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00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366,27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0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33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7893152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>
                          <a:effectLst/>
                        </a:rPr>
                        <a:t> 36_1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0,399,43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8,410,91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.46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08,42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9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178,65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0.59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43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1725116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36_2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29,599,82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7,390,09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53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832,99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19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369,222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2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750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6921506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48_1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23,367,66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1,963,17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.99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279,48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48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123,72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0.53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28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5764940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48_2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7,637,90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4,795,58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45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144,43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70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91,36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84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5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9342912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>
                          <a:effectLst/>
                        </a:rPr>
                        <a:t> 60_1 </a:t>
                      </a:r>
                      <a:endParaRPr lang="en-GB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6,568,59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3,397,77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3.19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730,17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8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437,13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0.94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349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0320749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60_2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8,134,23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5,272,51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50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429,32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37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425,05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1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735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373430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60_3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0,109,830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5,030,101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87.34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486,90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20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583,16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44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966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0688354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72_1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5,451,23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32,687,14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20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097,70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.9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658,71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8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767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1228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72_2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31,036,499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8,697,808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46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1,912,556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16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419,49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35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64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8238404"/>
                  </a:ext>
                </a:extLst>
              </a:tr>
              <a:tr h="182574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000" b="1" u="none" strike="noStrike" dirty="0">
                          <a:effectLst/>
                        </a:rPr>
                        <a:t> 72_3 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44,030,873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9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40,801,397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highlight>
                            <a:srgbClr val="00FF00"/>
                          </a:highlight>
                        </a:rPr>
                        <a:t>92.67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00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2,650,44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.02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              575,66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1.31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336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86" marR="6086" marT="608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483246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0714D16-A4FD-4215-BFCD-17901C4141AE}"/>
              </a:ext>
            </a:extLst>
          </p:cNvPr>
          <p:cNvSpPr txBox="1"/>
          <p:nvPr/>
        </p:nvSpPr>
        <p:spPr>
          <a:xfrm>
            <a:off x="273979" y="5248816"/>
            <a:ext cx="35891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plice junctions</a:t>
            </a:r>
          </a:p>
          <a:p>
            <a:r>
              <a:rPr lang="en-GB" b="1" dirty="0"/>
              <a:t>Novel – 1,862</a:t>
            </a:r>
          </a:p>
          <a:p>
            <a:r>
              <a:rPr lang="en-GB" b="1" dirty="0"/>
              <a:t>Ensembl+1</a:t>
            </a:r>
            <a:r>
              <a:rPr lang="en-GB" b="1" baseline="30000" dirty="0"/>
              <a:t>st</a:t>
            </a:r>
            <a:r>
              <a:rPr lang="en-GB" b="1" dirty="0"/>
              <a:t> pass novel – 300,875</a:t>
            </a:r>
          </a:p>
          <a:p>
            <a:r>
              <a:rPr lang="en-GB" b="1" dirty="0"/>
              <a:t>Total – 302,73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DC2FDC-7254-406B-A2DD-962191B7C25B}"/>
              </a:ext>
            </a:extLst>
          </p:cNvPr>
          <p:cNvSpPr txBox="1"/>
          <p:nvPr/>
        </p:nvSpPr>
        <p:spPr>
          <a:xfrm>
            <a:off x="123290" y="1654139"/>
            <a:ext cx="4407613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-</a:t>
            </a:r>
            <a:r>
              <a:rPr lang="en-GB" dirty="0" err="1"/>
              <a:t>sjdbOverhang</a:t>
            </a:r>
            <a:r>
              <a:rPr lang="en-GB" dirty="0"/>
              <a:t> 100</a:t>
            </a:r>
          </a:p>
          <a:p>
            <a:r>
              <a:rPr lang="en-GB" dirty="0"/>
              <a:t>--</a:t>
            </a:r>
            <a:r>
              <a:rPr lang="en-GB" dirty="0" err="1"/>
              <a:t>outSAMprimaryFlag</a:t>
            </a:r>
            <a:r>
              <a:rPr lang="en-GB" dirty="0"/>
              <a:t> </a:t>
            </a:r>
            <a:r>
              <a:rPr lang="en-GB" dirty="0" err="1"/>
              <a:t>AllBestScore</a:t>
            </a:r>
            <a:endParaRPr lang="en-GB" dirty="0"/>
          </a:p>
          <a:p>
            <a:r>
              <a:rPr lang="en-GB" dirty="0"/>
              <a:t>--</a:t>
            </a:r>
            <a:r>
              <a:rPr lang="en-GB" dirty="0" err="1"/>
              <a:t>outFilterMismatchNmax</a:t>
            </a:r>
            <a:r>
              <a:rPr lang="en-GB" dirty="0"/>
              <a:t> 0</a:t>
            </a:r>
          </a:p>
          <a:p>
            <a:r>
              <a:rPr lang="en-GB" dirty="0"/>
              <a:t>--</a:t>
            </a:r>
            <a:r>
              <a:rPr lang="en-GB" dirty="0" err="1"/>
              <a:t>outSJfilterCountTotalMin</a:t>
            </a:r>
            <a:r>
              <a:rPr lang="en-GB" dirty="0"/>
              <a:t> 10 5 5 5</a:t>
            </a:r>
          </a:p>
          <a:p>
            <a:r>
              <a:rPr lang="en-GB" dirty="0"/>
              <a:t>--</a:t>
            </a:r>
            <a:r>
              <a:rPr lang="en-GB" dirty="0" err="1"/>
              <a:t>outSAMstrandField</a:t>
            </a:r>
            <a:r>
              <a:rPr lang="en-GB" dirty="0"/>
              <a:t> </a:t>
            </a:r>
            <a:r>
              <a:rPr lang="en-GB" dirty="0" err="1"/>
              <a:t>intronMotif</a:t>
            </a:r>
            <a:endParaRPr lang="en-GB" dirty="0"/>
          </a:p>
          <a:p>
            <a:r>
              <a:rPr lang="en-GB" dirty="0"/>
              <a:t>--</a:t>
            </a:r>
            <a:r>
              <a:rPr lang="en-GB" dirty="0" err="1"/>
              <a:t>outFilterIntronMotifs</a:t>
            </a:r>
            <a:r>
              <a:rPr lang="en-GB" dirty="0"/>
              <a:t> </a:t>
            </a:r>
            <a:r>
              <a:rPr lang="en-GB" dirty="0" err="1"/>
              <a:t>RemoveNoncanonical</a:t>
            </a:r>
            <a:endParaRPr lang="en-GB" dirty="0"/>
          </a:p>
          <a:p>
            <a:r>
              <a:rPr lang="en-GB" dirty="0"/>
              <a:t>--</a:t>
            </a:r>
            <a:r>
              <a:rPr lang="en-GB" dirty="0" err="1"/>
              <a:t>alignIntronMin</a:t>
            </a:r>
            <a:r>
              <a:rPr lang="en-GB" dirty="0"/>
              <a:t> 60</a:t>
            </a:r>
          </a:p>
          <a:p>
            <a:r>
              <a:rPr lang="en-GB" dirty="0"/>
              <a:t>--</a:t>
            </a:r>
            <a:r>
              <a:rPr lang="en-GB" dirty="0" err="1"/>
              <a:t>alignIntronMax</a:t>
            </a:r>
            <a:r>
              <a:rPr lang="en-GB" dirty="0"/>
              <a:t> 6000</a:t>
            </a:r>
          </a:p>
          <a:p>
            <a:r>
              <a:rPr lang="en-GB" dirty="0"/>
              <a:t>--</a:t>
            </a:r>
            <a:r>
              <a:rPr lang="en-GB" dirty="0" err="1"/>
              <a:t>outFilterScoreMinOverLread</a:t>
            </a:r>
            <a:r>
              <a:rPr lang="en-GB" dirty="0"/>
              <a:t> 0</a:t>
            </a:r>
          </a:p>
          <a:p>
            <a:r>
              <a:rPr lang="en-GB" dirty="0"/>
              <a:t>--</a:t>
            </a:r>
            <a:r>
              <a:rPr lang="en-GB" dirty="0" err="1"/>
              <a:t>outFilterMatchNminOverLread</a:t>
            </a:r>
            <a:r>
              <a:rPr lang="en-GB" dirty="0"/>
              <a:t> 0</a:t>
            </a:r>
          </a:p>
          <a:p>
            <a:r>
              <a:rPr lang="en-GB" dirty="0"/>
              <a:t>--</a:t>
            </a:r>
            <a:r>
              <a:rPr lang="en-GB" dirty="0" err="1"/>
              <a:t>alignMatesGapMax</a:t>
            </a:r>
            <a:r>
              <a:rPr lang="en-GB" dirty="0"/>
              <a:t> 4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C31844-1661-4F71-898F-79F959EFB476}"/>
              </a:ext>
            </a:extLst>
          </p:cNvPr>
          <p:cNvSpPr txBox="1"/>
          <p:nvPr/>
        </p:nvSpPr>
        <p:spPr>
          <a:xfrm>
            <a:off x="123290" y="2270593"/>
            <a:ext cx="2866490" cy="2769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2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F41E3E6-6254-47C1-8D22-8EC985781538}"/>
              </a:ext>
            </a:extLst>
          </p:cNvPr>
          <p:cNvSpPr/>
          <p:nvPr/>
        </p:nvSpPr>
        <p:spPr>
          <a:xfrm>
            <a:off x="123290" y="823658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dirty="0"/>
              <a:t>Input genome index file created with the novel splice junctions found in the 1</a:t>
            </a:r>
            <a:r>
              <a:rPr lang="en-GB" baseline="30000" dirty="0"/>
              <a:t>st</a:t>
            </a:r>
            <a:r>
              <a:rPr lang="en-GB" dirty="0"/>
              <a:t> pass mapping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8ECF28-6730-4777-BFC4-BE5C5B7FA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3</a:t>
            </a:fld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736978" y="259308"/>
            <a:ext cx="1583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able 3:</a:t>
            </a:r>
          </a:p>
        </p:txBody>
      </p:sp>
    </p:spTree>
    <p:extLst>
      <p:ext uri="{BB962C8B-B14F-4D97-AF65-F5344CB8AC3E}">
        <p14:creationId xmlns:p14="http://schemas.microsoft.com/office/powerpoint/2010/main" val="13004695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EB1C07A3-54A5-405D-8BA7-68905C50A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0A5B-3A5D-4F1B-9268-76F47EAFFF47}" type="slidenum">
              <a:rPr lang="en-GB" smtClean="0"/>
              <a:pPr/>
              <a:t>4</a:t>
            </a:fld>
            <a:endParaRPr lang="en-GB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90A4D02-7B0C-4814-9984-2CBA69CDAB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7713041"/>
              </p:ext>
            </p:extLst>
          </p:nvPr>
        </p:nvGraphicFramePr>
        <p:xfrm>
          <a:off x="2969141" y="858013"/>
          <a:ext cx="6253717" cy="53511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0743">
                  <a:extLst>
                    <a:ext uri="{9D8B030D-6E8A-4147-A177-3AD203B41FA5}">
                      <a16:colId xmlns:a16="http://schemas.microsoft.com/office/drawing/2014/main" val="1996016023"/>
                    </a:ext>
                  </a:extLst>
                </a:gridCol>
                <a:gridCol w="833829">
                  <a:extLst>
                    <a:ext uri="{9D8B030D-6E8A-4147-A177-3AD203B41FA5}">
                      <a16:colId xmlns:a16="http://schemas.microsoft.com/office/drawing/2014/main" val="9025735"/>
                    </a:ext>
                  </a:extLst>
                </a:gridCol>
                <a:gridCol w="833829">
                  <a:extLst>
                    <a:ext uri="{9D8B030D-6E8A-4147-A177-3AD203B41FA5}">
                      <a16:colId xmlns:a16="http://schemas.microsoft.com/office/drawing/2014/main" val="2590242514"/>
                    </a:ext>
                  </a:extLst>
                </a:gridCol>
                <a:gridCol w="833829">
                  <a:extLst>
                    <a:ext uri="{9D8B030D-6E8A-4147-A177-3AD203B41FA5}">
                      <a16:colId xmlns:a16="http://schemas.microsoft.com/office/drawing/2014/main" val="1295046159"/>
                    </a:ext>
                  </a:extLst>
                </a:gridCol>
                <a:gridCol w="833829">
                  <a:extLst>
                    <a:ext uri="{9D8B030D-6E8A-4147-A177-3AD203B41FA5}">
                      <a16:colId xmlns:a16="http://schemas.microsoft.com/office/drawing/2014/main" val="1125976937"/>
                    </a:ext>
                  </a:extLst>
                </a:gridCol>
                <a:gridCol w="833829">
                  <a:extLst>
                    <a:ext uri="{9D8B030D-6E8A-4147-A177-3AD203B41FA5}">
                      <a16:colId xmlns:a16="http://schemas.microsoft.com/office/drawing/2014/main" val="1032498664"/>
                    </a:ext>
                  </a:extLst>
                </a:gridCol>
                <a:gridCol w="833829">
                  <a:extLst>
                    <a:ext uri="{9D8B030D-6E8A-4147-A177-3AD203B41FA5}">
                      <a16:colId xmlns:a16="http://schemas.microsoft.com/office/drawing/2014/main" val="2658224691"/>
                    </a:ext>
                  </a:extLst>
                </a:gridCol>
              </a:tblGrid>
              <a:tr h="2551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 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</a:rPr>
                        <a:t>Number of genes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>
                          <a:effectLst/>
                        </a:rPr>
                        <a:t>Number of transcripts </a:t>
                      </a:r>
                      <a:endParaRPr lang="en-GB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6669265"/>
                  </a:ext>
                </a:extLst>
              </a:tr>
              <a:tr h="5037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 Sample ID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scallop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cufflinks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Stringtie2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scallop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cufflinks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600" b="1" u="none" strike="noStrike" dirty="0">
                          <a:effectLst/>
                        </a:rPr>
                        <a:t>Stringtie2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016791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 C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28838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894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424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555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08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238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9088938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 C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2892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28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431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856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8130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202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0042693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 C_3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957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4933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695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6129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1032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595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8326254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12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2944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4990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33668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973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206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225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5069494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12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984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055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3456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6154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305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392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8228384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24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669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38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3199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371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7992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60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3535757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24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883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894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3424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555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08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238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7598900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24_3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858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880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389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712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489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224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5866544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36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660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715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189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1169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76961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756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5223146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36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741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844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205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618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262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91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8497680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48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595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758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177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733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7659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658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2960054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48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822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50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285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6230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86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1033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4111228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60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860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49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426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748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529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259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4737302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60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727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04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280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4356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243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015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8630111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60_3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814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8641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304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698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85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0392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2907878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72_1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792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8729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2802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6714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073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0575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5021205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72_2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696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7895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132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378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7868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48204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8082080"/>
                  </a:ext>
                </a:extLst>
              </a:tr>
              <a:tr h="2551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600" b="1" u="none" strike="noStrike" dirty="0">
                          <a:effectLst/>
                        </a:rPr>
                        <a:t>72_3 </a:t>
                      </a:r>
                      <a:endParaRPr lang="en-GB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2944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49748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33707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>
                          <a:effectLst/>
                        </a:rPr>
                        <a:t>59770</a:t>
                      </a:r>
                      <a:endParaRPr lang="en-GB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82276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600" u="none" strike="noStrike" dirty="0">
                          <a:effectLst/>
                        </a:rPr>
                        <a:t>52907</a:t>
                      </a:r>
                      <a:endParaRPr lang="en-GB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438460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4BA898B-2864-4BE5-8EEC-EA1D23EF53CB}"/>
              </a:ext>
            </a:extLst>
          </p:cNvPr>
          <p:cNvSpPr txBox="1"/>
          <p:nvPr/>
        </p:nvSpPr>
        <p:spPr>
          <a:xfrm>
            <a:off x="736978" y="259308"/>
            <a:ext cx="1583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Table 6:</a:t>
            </a:r>
            <a:endParaRPr lang="en-US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4E9891-B4AE-4B25-80C3-08211A408AB6}"/>
              </a:ext>
            </a:extLst>
          </p:cNvPr>
          <p:cNvSpPr txBox="1"/>
          <p:nvPr/>
        </p:nvSpPr>
        <p:spPr>
          <a:xfrm>
            <a:off x="3160245" y="308225"/>
            <a:ext cx="58715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/>
              <a:t>Transcriptome assembly statistics of individual library</a:t>
            </a:r>
          </a:p>
        </p:txBody>
      </p:sp>
    </p:spTree>
    <p:extLst>
      <p:ext uri="{BB962C8B-B14F-4D97-AF65-F5344CB8AC3E}">
        <p14:creationId xmlns:p14="http://schemas.microsoft.com/office/powerpoint/2010/main" val="2621593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04033919[[fn=Circuit]]</Template>
  <TotalTime>9766</TotalTime>
  <Words>1230</Words>
  <Application>Microsoft Office PowerPoint</Application>
  <PresentationFormat>Widescreen</PresentationFormat>
  <Paragraphs>642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gesh Srikakulam</dc:creator>
  <cp:lastModifiedBy>Nagesh S</cp:lastModifiedBy>
  <cp:revision>407</cp:revision>
  <dcterms:created xsi:type="dcterms:W3CDTF">2019-08-15T01:35:40Z</dcterms:created>
  <dcterms:modified xsi:type="dcterms:W3CDTF">2022-07-09T20:43:09Z</dcterms:modified>
</cp:coreProperties>
</file>